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72" r:id="rId2"/>
  </p:sldIdLst>
  <p:sldSz cx="6858000" cy="9906000" type="A4"/>
  <p:notesSz cx="68580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66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140" autoAdjust="0"/>
  </p:normalViewPr>
  <p:slideViewPr>
    <p:cSldViewPr snapToGrid="0">
      <p:cViewPr varScale="1">
        <p:scale>
          <a:sx n="77" d="100"/>
          <a:sy n="77" d="100"/>
        </p:scale>
        <p:origin x="313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E94B2D-07F7-458A-87E3-485A4D884D54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431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73892"/>
            <a:ext cx="5486400" cy="366045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9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2687F9-746E-40BC-875D-08F4D7275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440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51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464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982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154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720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853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77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604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90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182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396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02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91108E5-7482-4C57-A2A2-768B77A2DC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316" y="1403307"/>
            <a:ext cx="6139914" cy="27051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D3F8D25B-B582-4AB8-BCE7-C1337CF8F16E}"/>
              </a:ext>
            </a:extLst>
          </p:cNvPr>
          <p:cNvSpPr/>
          <p:nvPr/>
        </p:nvSpPr>
        <p:spPr>
          <a:xfrm>
            <a:off x="455691" y="4198982"/>
            <a:ext cx="6189359" cy="6848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312"/>
              </a:spcAft>
            </a:pPr>
            <a:r>
              <a:rPr lang="en-US" sz="1200" b="1" dirty="0">
                <a:solidFill>
                  <a:srgbClr val="000000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Supplementary Figure 3.</a:t>
            </a:r>
          </a:p>
          <a:p>
            <a:pPr>
              <a:spcAft>
                <a:spcPts val="312"/>
              </a:spcAft>
            </a:pP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VB-85247 induce cytokine response in human PBMC with different STING variants. Each point represent the EC50 value from a single donor. The median EC</a:t>
            </a:r>
            <a:r>
              <a:rPr lang="en-US" sz="1200" baseline="-25000" dirty="0">
                <a:solidFill>
                  <a:srgbClr val="000000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50</a:t>
            </a: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 is represented by the line. </a:t>
            </a:r>
            <a:endParaRPr lang="en-US" sz="1600" dirty="0"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1">
            <a:extLst>
              <a:ext uri="{FF2B5EF4-FFF2-40B4-BE49-F238E27FC236}">
                <a16:creationId xmlns:a16="http://schemas.microsoft.com/office/drawing/2014/main" id="{F792ACB9-1B61-4694-BF2D-04D1C40B3EAC}"/>
              </a:ext>
            </a:extLst>
          </p:cNvPr>
          <p:cNvSpPr txBox="1"/>
          <p:nvPr/>
        </p:nvSpPr>
        <p:spPr>
          <a:xfrm>
            <a:off x="4055337" y="11509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630630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40</TotalTime>
  <Words>39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glena Prabagar</dc:creator>
  <cp:lastModifiedBy>Miglena Prabagar</cp:lastModifiedBy>
  <cp:revision>300</cp:revision>
  <cp:lastPrinted>2024-06-07T20:20:11Z</cp:lastPrinted>
  <dcterms:created xsi:type="dcterms:W3CDTF">2021-09-21T12:05:42Z</dcterms:created>
  <dcterms:modified xsi:type="dcterms:W3CDTF">2024-11-26T15:49:18Z</dcterms:modified>
</cp:coreProperties>
</file>